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74" r:id="rId2"/>
    <p:sldId id="280" r:id="rId3"/>
    <p:sldId id="295" r:id="rId4"/>
    <p:sldId id="281" r:id="rId5"/>
    <p:sldId id="283" r:id="rId6"/>
    <p:sldId id="284" r:id="rId7"/>
    <p:sldId id="286" r:id="rId8"/>
    <p:sldId id="287" r:id="rId9"/>
    <p:sldId id="288" r:id="rId10"/>
    <p:sldId id="290" r:id="rId11"/>
    <p:sldId id="291" r:id="rId12"/>
    <p:sldId id="279" r:id="rId13"/>
    <p:sldId id="297" r:id="rId14"/>
  </p:sldIdLst>
  <p:sldSz cx="6858000" cy="9906000" type="A4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avier" initials="j" lastIdx="11" clrIdx="0"/>
  <p:cmAuthor id="1" name="Azahara Rodriguez Luna" initials="ARL" lastIdx="7" clrIdx="1"/>
  <p:cmAuthor id="2" name="arodriguez53@us.es " initials="a" lastIdx="2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2" autoAdjust="0"/>
    <p:restoredTop sz="94434" autoAdjust="0"/>
  </p:normalViewPr>
  <p:slideViewPr>
    <p:cSldViewPr snapToGrid="0" showGuides="1">
      <p:cViewPr>
        <p:scale>
          <a:sx n="150" d="100"/>
          <a:sy n="150" d="100"/>
        </p:scale>
        <p:origin x="1476" y="-1188"/>
      </p:cViewPr>
      <p:guideLst>
        <p:guide orient="horz" pos="3097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19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5631" cy="512304"/>
          </a:xfrm>
          <a:prstGeom prst="rect">
            <a:avLst/>
          </a:prstGeom>
        </p:spPr>
        <p:txBody>
          <a:bodyPr vert="horz" lIns="95500" tIns="47750" rIns="95500" bIns="47750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021979" y="0"/>
            <a:ext cx="3075631" cy="512304"/>
          </a:xfrm>
          <a:prstGeom prst="rect">
            <a:avLst/>
          </a:prstGeom>
        </p:spPr>
        <p:txBody>
          <a:bodyPr vert="horz" lIns="95500" tIns="47750" rIns="95500" bIns="47750" rtlCol="0"/>
          <a:lstStyle>
            <a:lvl1pPr algn="r">
              <a:defRPr sz="1300"/>
            </a:lvl1pPr>
          </a:lstStyle>
          <a:p>
            <a:fld id="{40AA8A1F-56A8-40AC-837A-81CCB3651AA6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00" tIns="47750" rIns="95500" bIns="4775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09761" y="4924989"/>
            <a:ext cx="5679778" cy="4029684"/>
          </a:xfrm>
          <a:prstGeom prst="rect">
            <a:avLst/>
          </a:prstGeom>
        </p:spPr>
        <p:txBody>
          <a:bodyPr vert="horz" lIns="95500" tIns="47750" rIns="95500" bIns="4775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722309"/>
            <a:ext cx="3075631" cy="512304"/>
          </a:xfrm>
          <a:prstGeom prst="rect">
            <a:avLst/>
          </a:prstGeom>
        </p:spPr>
        <p:txBody>
          <a:bodyPr vert="horz" lIns="95500" tIns="47750" rIns="95500" bIns="47750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1979" y="9722309"/>
            <a:ext cx="3075631" cy="512304"/>
          </a:xfrm>
          <a:prstGeom prst="rect">
            <a:avLst/>
          </a:prstGeom>
        </p:spPr>
        <p:txBody>
          <a:bodyPr vert="horz" lIns="95500" tIns="47750" rIns="95500" bIns="47750" rtlCol="0" anchor="b"/>
          <a:lstStyle>
            <a:lvl1pPr algn="r">
              <a:defRPr sz="1300"/>
            </a:lvl1pPr>
          </a:lstStyle>
          <a:p>
            <a:fld id="{50B9A526-01C9-4E11-8C6A-356B5B98D86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95233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7905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9393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848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2218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6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287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9275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6025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9098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0373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6209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BF4C1-2A4A-42F4-8D2E-B813C06387D5}" type="datetimeFigureOut">
              <a:rPr lang="es-ES" smtClean="0"/>
              <a:t>17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39572-83FF-4694-9016-EF2F3E17EA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9495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C4CF1A36-4578-7EA3-26D7-ED05D014C563}"/>
              </a:ext>
            </a:extLst>
          </p:cNvPr>
          <p:cNvSpPr txBox="1"/>
          <p:nvPr/>
        </p:nvSpPr>
        <p:spPr>
          <a:xfrm>
            <a:off x="365344" y="3725975"/>
            <a:ext cx="57070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lang="en-US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of THP-1 human macrophages treated with different concentrations of phenolics 1, 1a and 1b</a:t>
            </a:r>
            <a:r>
              <a:rPr lang="es-ES" sz="12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 ± SEM (%), (n = 4).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EF952C32-6C6D-F83B-90B2-7A709E353DF7}"/>
              </a:ext>
            </a:extLst>
          </p:cNvPr>
          <p:cNvSpPr txBox="1"/>
          <p:nvPr/>
        </p:nvSpPr>
        <p:spPr>
          <a:xfrm>
            <a:off x="418542" y="849338"/>
            <a:ext cx="62915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Evaluation of the antioxidant capacity of the phenolics 1, 1a and 1b by using ABTS assay.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ferent concentrations of Trolox were used as positive control and the same concentrations were tested of the phenolics</a:t>
            </a:r>
            <a:r>
              <a:rPr lang="es-ES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alues are mean ± SEM (%), (n = 4).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id="{3C7A9A25-7FE5-0928-8DB3-6640DBDE46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8484687"/>
              </p:ext>
            </p:extLst>
          </p:nvPr>
        </p:nvGraphicFramePr>
        <p:xfrm>
          <a:off x="628650" y="4329499"/>
          <a:ext cx="5600700" cy="914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3252">
                  <a:extLst>
                    <a:ext uri="{9D8B030D-6E8A-4147-A177-3AD203B41FA5}">
                      <a16:colId xmlns:a16="http://schemas.microsoft.com/office/drawing/2014/main" val="794840657"/>
                    </a:ext>
                  </a:extLst>
                </a:gridCol>
                <a:gridCol w="909697">
                  <a:extLst>
                    <a:ext uri="{9D8B030D-6E8A-4147-A177-3AD203B41FA5}">
                      <a16:colId xmlns:a16="http://schemas.microsoft.com/office/drawing/2014/main" val="2642613694"/>
                    </a:ext>
                  </a:extLst>
                </a:gridCol>
                <a:gridCol w="855115">
                  <a:extLst>
                    <a:ext uri="{9D8B030D-6E8A-4147-A177-3AD203B41FA5}">
                      <a16:colId xmlns:a16="http://schemas.microsoft.com/office/drawing/2014/main" val="3787428576"/>
                    </a:ext>
                  </a:extLst>
                </a:gridCol>
                <a:gridCol w="864212">
                  <a:extLst>
                    <a:ext uri="{9D8B030D-6E8A-4147-A177-3AD203B41FA5}">
                      <a16:colId xmlns:a16="http://schemas.microsoft.com/office/drawing/2014/main" val="3479574884"/>
                    </a:ext>
                  </a:extLst>
                </a:gridCol>
                <a:gridCol w="873309">
                  <a:extLst>
                    <a:ext uri="{9D8B030D-6E8A-4147-A177-3AD203B41FA5}">
                      <a16:colId xmlns:a16="http://schemas.microsoft.com/office/drawing/2014/main" val="3501904991"/>
                    </a:ext>
                  </a:extLst>
                </a:gridCol>
                <a:gridCol w="855115">
                  <a:extLst>
                    <a:ext uri="{9D8B030D-6E8A-4147-A177-3AD203B41FA5}">
                      <a16:colId xmlns:a16="http://schemas.microsoft.com/office/drawing/2014/main" val="2701645278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u="none" strike="noStrike" dirty="0">
                          <a:effectLst/>
                        </a:rPr>
                        <a:t> 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% Viability THP-1 macrophages (48 h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285697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 err="1">
                          <a:effectLst/>
                        </a:rPr>
                        <a:t>Compounds</a:t>
                      </a:r>
                      <a:r>
                        <a:rPr lang="es-ES" sz="1100" u="none" strike="noStrike" dirty="0">
                          <a:effectLst/>
                        </a:rPr>
                        <a:t> (µM)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6.25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12.5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25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50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100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761118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101.51 ± 4.30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100.47 ± 4.45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107.94 ± 1.46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100.25 ± 2.41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95.28 ± 3.31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6314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u="none" strike="noStrike" dirty="0">
                          <a:effectLst/>
                        </a:rPr>
                        <a:t>1a</a:t>
                      </a:r>
                      <a:endParaRPr lang="es-E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94.14 ± 0.85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88.71 ± 1.91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88.38 ± 1.68 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72.27 ± 2.62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59.74 ± 2.44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26864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u="none" strike="noStrike" dirty="0">
                          <a:effectLst/>
                        </a:rPr>
                        <a:t>1b</a:t>
                      </a:r>
                      <a:endParaRPr lang="es-E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101.67 ± 1.10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99.20 ± 1.54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95.59 ± 2.67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88.86 ± 0.99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</a:rPr>
                        <a:t>87.25 ± 1.20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5313265"/>
                  </a:ext>
                </a:extLst>
              </a:tr>
            </a:tbl>
          </a:graphicData>
        </a:graphic>
      </p:graphicFrame>
      <p:graphicFrame>
        <p:nvGraphicFramePr>
          <p:cNvPr id="8" name="Tabla 7">
            <a:extLst>
              <a:ext uri="{FF2B5EF4-FFF2-40B4-BE49-F238E27FC236}">
                <a16:creationId xmlns:a16="http://schemas.microsoft.com/office/drawing/2014/main" id="{88CF0E57-6BB9-9FAB-4096-74BFDC1DC4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6678226"/>
              </p:ext>
            </p:extLst>
          </p:nvPr>
        </p:nvGraphicFramePr>
        <p:xfrm>
          <a:off x="118871" y="1662726"/>
          <a:ext cx="6591208" cy="15544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59881">
                  <a:extLst>
                    <a:ext uri="{9D8B030D-6E8A-4147-A177-3AD203B41FA5}">
                      <a16:colId xmlns:a16="http://schemas.microsoft.com/office/drawing/2014/main" val="3274605379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31560208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1945425115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960320175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2431946200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524418432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1469050500"/>
                    </a:ext>
                  </a:extLst>
                </a:gridCol>
                <a:gridCol w="620965">
                  <a:extLst>
                    <a:ext uri="{9D8B030D-6E8A-4147-A177-3AD203B41FA5}">
                      <a16:colId xmlns:a16="http://schemas.microsoft.com/office/drawing/2014/main" val="1098893695"/>
                    </a:ext>
                  </a:extLst>
                </a:gridCol>
                <a:gridCol w="411483">
                  <a:extLst>
                    <a:ext uri="{9D8B030D-6E8A-4147-A177-3AD203B41FA5}">
                      <a16:colId xmlns:a16="http://schemas.microsoft.com/office/drawing/2014/main" val="738592385"/>
                    </a:ext>
                  </a:extLst>
                </a:gridCol>
                <a:gridCol w="773089">
                  <a:extLst>
                    <a:ext uri="{9D8B030D-6E8A-4147-A177-3AD203B41FA5}">
                      <a16:colId xmlns:a16="http://schemas.microsoft.com/office/drawing/2014/main" val="263268765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% Antioxidant potential of phenolic compounds by using ABTS assay</a:t>
                      </a:r>
                      <a:endParaRPr lang="en-U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6861729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 err="1">
                          <a:effectLst/>
                          <a:latin typeface="+mn-lt"/>
                        </a:rPr>
                        <a:t>Compounds</a:t>
                      </a:r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 (µM)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>
                          <a:effectLst/>
                          <a:latin typeface="+mn-lt"/>
                        </a:rPr>
                        <a:t>6.25</a:t>
                      </a:r>
                      <a:endParaRPr lang="es-ES" sz="1100" b="0" i="0" u="none" strike="noStrike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12.5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25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50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100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>
                          <a:effectLst/>
                          <a:latin typeface="+mn-lt"/>
                        </a:rPr>
                        <a:t>200</a:t>
                      </a:r>
                      <a:endParaRPr lang="es-ES" sz="1100" b="0" i="0" u="none" strike="noStrike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400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EC50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TEAC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5000795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u="none" strike="noStrike" dirty="0">
                          <a:effectLst/>
                          <a:latin typeface="+mn-lt"/>
                        </a:rPr>
                        <a:t>TROLOX</a:t>
                      </a:r>
                      <a:endParaRPr lang="es-ES" sz="1100" b="1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13.07 ± 1.01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20.56 ± 1.13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>
                          <a:effectLst/>
                          <a:latin typeface="+mn-lt"/>
                        </a:rPr>
                        <a:t>51.54 ± 4.38</a:t>
                      </a:r>
                      <a:endParaRPr lang="es-ES" sz="1100" b="0" i="0" u="none" strike="noStrike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>
                          <a:effectLst/>
                          <a:latin typeface="+mn-lt"/>
                        </a:rPr>
                        <a:t>87.49 ± 1.67</a:t>
                      </a:r>
                      <a:endParaRPr lang="es-ES" sz="1100" b="0" i="0" u="none" strike="noStrike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94.57 ± 0.71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93.22 ± 1.06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95.55 ± 0.52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>
                          <a:effectLst/>
                          <a:latin typeface="+mn-lt"/>
                        </a:rPr>
                        <a:t>24.15</a:t>
                      </a:r>
                      <a:endParaRPr lang="es-ES" sz="1100" b="0" i="0" u="none" strike="noStrike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>
                          <a:effectLst/>
                          <a:latin typeface="+mn-lt"/>
                        </a:rPr>
                        <a:t>1</a:t>
                      </a:r>
                      <a:endParaRPr lang="es-ES" sz="1100" b="0" i="0" u="none" strike="noStrike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8787322"/>
                  </a:ext>
                </a:extLst>
              </a:tr>
              <a:tr h="113678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u="none" strike="noStrike" dirty="0">
                          <a:effectLst/>
                          <a:latin typeface="+mn-lt"/>
                        </a:rPr>
                        <a:t>1</a:t>
                      </a:r>
                      <a:endParaRPr lang="es-ES" sz="1100" b="1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6.17 ± 1.43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12.55 ± 0.65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23.05 ± 1.31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53.87 ± 0.80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366.68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15.18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4778771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u="none" strike="noStrike" dirty="0">
                          <a:effectLst/>
                          <a:latin typeface="+mn-lt"/>
                        </a:rPr>
                        <a:t>1a</a:t>
                      </a:r>
                      <a:endParaRPr lang="es-ES" sz="1100" b="1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1.65 ± 0.19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4.58 ± 0.33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3.54 ± 0.88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6.59 ± 0.16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4189383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b="1" u="none" strike="noStrike" dirty="0">
                          <a:effectLst/>
                          <a:latin typeface="+mn-lt"/>
                        </a:rPr>
                        <a:t>1b</a:t>
                      </a:r>
                      <a:endParaRPr lang="es-ES" sz="1100" b="1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3.84 ±1.80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nd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1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25846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679218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35265A0C-FBC7-E358-3B76-F442E59D3C5B}"/>
              </a:ext>
            </a:extLst>
          </p:cNvPr>
          <p:cNvSpPr txBox="1"/>
          <p:nvPr/>
        </p:nvSpPr>
        <p:spPr>
          <a:xfrm>
            <a:off x="154750" y="8532219"/>
            <a:ext cx="643430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9. COSY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and NOESY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ethylcarbonate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ethylcarbonatechrysin.</a:t>
            </a:r>
            <a:endParaRPr lang="es-MX" b="1" dirty="0"/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C8A87A10-96EE-7557-FCE7-B7B495CE235A}"/>
              </a:ext>
            </a:extLst>
          </p:cNvPr>
          <p:cNvGrpSpPr/>
          <p:nvPr/>
        </p:nvGrpSpPr>
        <p:grpSpPr>
          <a:xfrm>
            <a:off x="713308" y="411996"/>
            <a:ext cx="5511152" cy="8039836"/>
            <a:chOff x="713308" y="411996"/>
            <a:chExt cx="5511152" cy="8039836"/>
          </a:xfrm>
        </p:grpSpPr>
        <p:pic>
          <p:nvPicPr>
            <p:cNvPr id="10242" name="Picture 2">
              <a:extLst>
                <a:ext uri="{FF2B5EF4-FFF2-40B4-BE49-F238E27FC236}">
                  <a16:creationId xmlns:a16="http://schemas.microsoft.com/office/drawing/2014/main" id="{166DF718-CB0E-15B5-28C6-A631A3CD48E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1081" b="29532"/>
            <a:stretch>
              <a:fillRect/>
            </a:stretch>
          </p:blipFill>
          <p:spPr bwMode="auto">
            <a:xfrm>
              <a:off x="715494" y="411996"/>
              <a:ext cx="5508966" cy="40276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43" name="Picture 3">
              <a:extLst>
                <a:ext uri="{FF2B5EF4-FFF2-40B4-BE49-F238E27FC236}">
                  <a16:creationId xmlns:a16="http://schemas.microsoft.com/office/drawing/2014/main" id="{007B6EF9-D04F-66BE-484C-9EA285D93EE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1724" y="4439650"/>
              <a:ext cx="5376505" cy="40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DB6E6831-F6F3-153E-7AE7-8E8B41FCAC88}"/>
                </a:ext>
              </a:extLst>
            </p:cNvPr>
            <p:cNvSpPr txBox="1"/>
            <p:nvPr/>
          </p:nvSpPr>
          <p:spPr>
            <a:xfrm>
              <a:off x="717722" y="72745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9117699A-02FF-78F4-81E6-EC9761972F57}"/>
                </a:ext>
              </a:extLst>
            </p:cNvPr>
            <p:cNvSpPr txBox="1"/>
            <p:nvPr/>
          </p:nvSpPr>
          <p:spPr>
            <a:xfrm>
              <a:off x="713308" y="4949444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767713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>
            <a:extLst>
              <a:ext uri="{FF2B5EF4-FFF2-40B4-BE49-F238E27FC236}">
                <a16:creationId xmlns:a16="http://schemas.microsoft.com/office/drawing/2014/main" id="{F01BE3BA-6E34-0113-5A37-8AEDFBBE4B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737" y="710618"/>
            <a:ext cx="5477882" cy="4091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1BC39E58-D517-E0AF-1E62-42486593A282}"/>
              </a:ext>
            </a:extLst>
          </p:cNvPr>
          <p:cNvSpPr txBox="1"/>
          <p:nvPr/>
        </p:nvSpPr>
        <p:spPr>
          <a:xfrm>
            <a:off x="358587" y="5103560"/>
            <a:ext cx="563880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10. HETCOR spectrum of 8-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ethylcarbonate-</a:t>
            </a:r>
            <a:r>
              <a:rPr lang="es-MX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ethylcarbonatechrysin.</a:t>
            </a:r>
            <a:endParaRPr lang="es-MX" b="1" dirty="0"/>
          </a:p>
        </p:txBody>
      </p:sp>
    </p:spTree>
    <p:extLst>
      <p:ext uri="{BB962C8B-B14F-4D97-AF65-F5344CB8AC3E}">
        <p14:creationId xmlns:p14="http://schemas.microsoft.com/office/powerpoint/2010/main" val="37557591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1937D746-2AE7-8F16-9B8B-2BE2D63B3C8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4902" y="946607"/>
            <a:ext cx="2068195" cy="766445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5EF3C568-9577-B33F-9744-D0D420524D5E}"/>
              </a:ext>
            </a:extLst>
          </p:cNvPr>
          <p:cNvSpPr txBox="1"/>
          <p:nvPr/>
        </p:nvSpPr>
        <p:spPr>
          <a:xfrm>
            <a:off x="579849" y="8797018"/>
            <a:ext cx="56983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1. Global-minimum conformers of compounds 1, 1a and 1b at the B3LYP/DGDZVP level of theory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MX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07160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E57102B2-2E55-4C2C-8B19-7B4B5E4554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856" y="542432"/>
            <a:ext cx="6560288" cy="478527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ADFF1963-E0F2-41DA-897A-22FC6BE01125}"/>
              </a:ext>
            </a:extLst>
          </p:cNvPr>
          <p:cNvSpPr txBox="1"/>
          <p:nvPr/>
        </p:nvSpPr>
        <p:spPr>
          <a:xfrm>
            <a:off x="148857" y="5805377"/>
            <a:ext cx="65602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. Theorethical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ochemical and lipophillicity properties </a:t>
            </a:r>
            <a:r>
              <a:rPr lang="es-MX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MX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und</a:t>
            </a:r>
            <a:r>
              <a:rPr lang="es-MX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and 1a.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acquired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wissADM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 free web tool to evaluate pharmacokinetics, drug-likeness and medicinal chemistry friendliness of small molecules, 2017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.1038/srep42717. </a:t>
            </a:r>
            <a:endParaRPr lang="es-MX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0677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8B260232-F23A-0BA3-EBA8-0B9724CC7D77}"/>
              </a:ext>
            </a:extLst>
          </p:cNvPr>
          <p:cNvGrpSpPr/>
          <p:nvPr/>
        </p:nvGrpSpPr>
        <p:grpSpPr>
          <a:xfrm>
            <a:off x="1134608" y="246744"/>
            <a:ext cx="4152208" cy="7450482"/>
            <a:chOff x="1134608" y="246744"/>
            <a:chExt cx="4152208" cy="7450482"/>
          </a:xfrm>
        </p:grpSpPr>
        <p:pic>
          <p:nvPicPr>
            <p:cNvPr id="2" name="Imagen 1" descr="Imagen que contiene interior, tabla, collar, computer&#10;&#10;Descripción generada automáticamente">
              <a:extLst>
                <a:ext uri="{FF2B5EF4-FFF2-40B4-BE49-F238E27FC236}">
                  <a16:creationId xmlns:a16="http://schemas.microsoft.com/office/drawing/2014/main" id="{D7ABDD3E-B823-AB75-D589-46F970A31C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57" r="27408"/>
            <a:stretch/>
          </p:blipFill>
          <p:spPr>
            <a:xfrm>
              <a:off x="1134608" y="3592293"/>
              <a:ext cx="4152208" cy="4104933"/>
            </a:xfrm>
            <a:prstGeom prst="rect">
              <a:avLst/>
            </a:prstGeom>
          </p:spPr>
        </p:pic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41BCDDDE-6CA0-75D2-D467-425F3D2962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78" r="27408"/>
            <a:stretch/>
          </p:blipFill>
          <p:spPr>
            <a:xfrm>
              <a:off x="1712688" y="246744"/>
              <a:ext cx="3319630" cy="3570514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0E9FA687-EE70-B491-46ED-ED0F01AE7B1D}"/>
                </a:ext>
              </a:extLst>
            </p:cNvPr>
            <p:cNvSpPr txBox="1"/>
            <p:nvPr/>
          </p:nvSpPr>
          <p:spPr>
            <a:xfrm>
              <a:off x="1437907" y="48473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s-MX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4CAF7326-B54C-63C2-FD05-BB0E0F39F6FB}"/>
                </a:ext>
              </a:extLst>
            </p:cNvPr>
            <p:cNvSpPr txBox="1"/>
            <p:nvPr/>
          </p:nvSpPr>
          <p:spPr>
            <a:xfrm>
              <a:off x="1445166" y="3830287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s-MX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7" name="CuadroTexto 6">
            <a:extLst>
              <a:ext uri="{FF2B5EF4-FFF2-40B4-BE49-F238E27FC236}">
                <a16:creationId xmlns:a16="http://schemas.microsoft.com/office/drawing/2014/main" id="{E5033A11-17CD-346C-448A-EDC2B7BA9F01}"/>
              </a:ext>
            </a:extLst>
          </p:cNvPr>
          <p:cNvSpPr txBox="1"/>
          <p:nvPr/>
        </p:nvSpPr>
        <p:spPr>
          <a:xfrm>
            <a:off x="231037" y="7905452"/>
            <a:ext cx="6395925" cy="17235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. (A) Validation of docking performance by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AutoDock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Vina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Th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cocrystalized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and docked (inhibitor K67) ligands are shown as in brown and blue color, respectively.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B) Comparison of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cocrystalized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and docked (inhibitor K67) ligand interactions in structure of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Kelch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like ECH associated Protein-1 (Keap1).</a:t>
            </a:r>
            <a:endParaRPr lang="es-MX" b="1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/>
            <a:endParaRPr lang="es-MX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9370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87482730-9E15-2949-FDF7-69AD3B89868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89"/>
          <a:stretch/>
        </p:blipFill>
        <p:spPr>
          <a:xfrm>
            <a:off x="72571" y="292438"/>
            <a:ext cx="6712857" cy="1921084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200E1A7E-694E-2D9C-04E2-359F84DD90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315" y="2311329"/>
            <a:ext cx="5611368" cy="864108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56AFC49B-B752-B615-4936-7CE3C90F6D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114693"/>
            <a:ext cx="6858000" cy="1742595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B6D90F12-FE96-E1F5-208E-609B87D11A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2460" y="4952329"/>
            <a:ext cx="5611368" cy="864108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E5C520D3-906B-2A60-03EF-F0DD8FDB824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5715117"/>
            <a:ext cx="6858000" cy="172352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6FF4D35A-D269-2F32-81D2-9E823F2226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3316" y="7562143"/>
            <a:ext cx="5611368" cy="864108"/>
          </a:xfrm>
          <a:prstGeom prst="rect">
            <a:avLst/>
          </a:prstGeom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5E9DD495-35C7-43F0-5AE5-4C0A5F0861EF}"/>
              </a:ext>
            </a:extLst>
          </p:cNvPr>
          <p:cNvSpPr txBox="1"/>
          <p:nvPr/>
        </p:nvSpPr>
        <p:spPr>
          <a:xfrm>
            <a:off x="172430" y="8510337"/>
            <a:ext cx="6531427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2. HPLC analysis of 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lucopyranosylchrysin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A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), 8-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acetyl-</a:t>
            </a:r>
            <a:r>
              <a:rPr lang="es-MX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acetylchrysin (B) and 8-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ethylcarbonate-</a:t>
            </a:r>
            <a:r>
              <a:rPr lang="es-MX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ethylcarbonatechrysin (C).</a:t>
            </a:r>
            <a:endParaRPr lang="es-MX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077B7BE-E395-0B73-9F0A-9A4D06306C1D}"/>
              </a:ext>
            </a:extLst>
          </p:cNvPr>
          <p:cNvSpPr txBox="1"/>
          <p:nvPr/>
        </p:nvSpPr>
        <p:spPr>
          <a:xfrm>
            <a:off x="172430" y="4034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20A9300-015B-12B6-1E8D-D57C235E5BE3}"/>
              </a:ext>
            </a:extLst>
          </p:cNvPr>
          <p:cNvSpPr txBox="1"/>
          <p:nvPr/>
        </p:nvSpPr>
        <p:spPr>
          <a:xfrm>
            <a:off x="176913" y="276112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FE3F7EA-A926-1A58-3E42-833D95B17B72}"/>
              </a:ext>
            </a:extLst>
          </p:cNvPr>
          <p:cNvSpPr txBox="1"/>
          <p:nvPr/>
        </p:nvSpPr>
        <p:spPr>
          <a:xfrm>
            <a:off x="176913" y="539675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625494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5EF0C07B-B08A-EE61-BE4E-F10DD8CD54E0}"/>
              </a:ext>
            </a:extLst>
          </p:cNvPr>
          <p:cNvGrpSpPr/>
          <p:nvPr/>
        </p:nvGrpSpPr>
        <p:grpSpPr>
          <a:xfrm>
            <a:off x="437029" y="537882"/>
            <a:ext cx="5983941" cy="7827729"/>
            <a:chOff x="-1" y="0"/>
            <a:chExt cx="6858001" cy="8674894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4E45D754-1AD5-5491-9853-B8151B960873}"/>
                </a:ext>
              </a:extLst>
            </p:cNvPr>
            <p:cNvGrpSpPr/>
            <p:nvPr/>
          </p:nvGrpSpPr>
          <p:grpSpPr>
            <a:xfrm>
              <a:off x="-1" y="306376"/>
              <a:ext cx="6858001" cy="8368518"/>
              <a:chOff x="-1" y="306376"/>
              <a:chExt cx="6858001" cy="8368518"/>
            </a:xfrm>
          </p:grpSpPr>
          <p:pic>
            <p:nvPicPr>
              <p:cNvPr id="1026" name="Picture 2">
                <a:extLst>
                  <a:ext uri="{FF2B5EF4-FFF2-40B4-BE49-F238E27FC236}">
                    <a16:creationId xmlns:a16="http://schemas.microsoft.com/office/drawing/2014/main" id="{D90F19E6-3161-FD08-C7C2-9BF30AA1DEB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" y="306376"/>
                <a:ext cx="6858001" cy="49544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" name="Picture 2">
                <a:extLst>
                  <a:ext uri="{FF2B5EF4-FFF2-40B4-BE49-F238E27FC236}">
                    <a16:creationId xmlns:a16="http://schemas.microsoft.com/office/drawing/2014/main" id="{B510B531-840A-F2EF-05F3-49E7E43A2E6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8074"/>
              <a:stretch/>
            </p:blipFill>
            <p:spPr bwMode="auto">
              <a:xfrm>
                <a:off x="-1" y="6388768"/>
                <a:ext cx="6858001" cy="2286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" name="Picture 2">
                <a:extLst>
                  <a:ext uri="{FF2B5EF4-FFF2-40B4-BE49-F238E27FC236}">
                    <a16:creationId xmlns:a16="http://schemas.microsoft.com/office/drawing/2014/main" id="{5A6C99C7-C197-4314-4F1C-94625A56232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1272"/>
              <a:stretch/>
            </p:blipFill>
            <p:spPr bwMode="auto">
              <a:xfrm>
                <a:off x="-1" y="5709101"/>
                <a:ext cx="6858001" cy="140156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790197C1-F976-8FCE-293E-313592C2A9C3}"/>
                </a:ext>
              </a:extLst>
            </p:cNvPr>
            <p:cNvSpPr txBox="1"/>
            <p:nvPr/>
          </p:nvSpPr>
          <p:spPr>
            <a:xfrm>
              <a:off x="0" y="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397BF4A9-F383-57AE-0B55-B086423E15FD}"/>
                </a:ext>
              </a:extLst>
            </p:cNvPr>
            <p:cNvSpPr txBox="1"/>
            <p:nvPr/>
          </p:nvSpPr>
          <p:spPr>
            <a:xfrm>
              <a:off x="0" y="530554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7" name="CuadroTexto 6">
            <a:extLst>
              <a:ext uri="{FF2B5EF4-FFF2-40B4-BE49-F238E27FC236}">
                <a16:creationId xmlns:a16="http://schemas.microsoft.com/office/drawing/2014/main" id="{0742F203-BA44-094C-E38E-AFCDA1CB1E4A}"/>
              </a:ext>
            </a:extLst>
          </p:cNvPr>
          <p:cNvSpPr txBox="1"/>
          <p:nvPr/>
        </p:nvSpPr>
        <p:spPr>
          <a:xfrm>
            <a:off x="545976" y="8732000"/>
            <a:ext cx="653142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NMR 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ucopyranosylchrysin</a:t>
            </a:r>
            <a:endParaRPr lang="es-MX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MX" b="1" dirty="0"/>
          </a:p>
        </p:txBody>
      </p:sp>
    </p:spTree>
    <p:extLst>
      <p:ext uri="{BB962C8B-B14F-4D97-AF65-F5344CB8AC3E}">
        <p14:creationId xmlns:p14="http://schemas.microsoft.com/office/powerpoint/2010/main" val="2760886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D85CB415-AAEB-C0DB-1EE7-C619153DF73F}"/>
              </a:ext>
            </a:extLst>
          </p:cNvPr>
          <p:cNvSpPr txBox="1"/>
          <p:nvPr/>
        </p:nvSpPr>
        <p:spPr>
          <a:xfrm>
            <a:off x="145143" y="8639408"/>
            <a:ext cx="653142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4. COSY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and NOESY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lucopyranosylchrysin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s-MX" b="1" dirty="0"/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5984CB91-0174-7939-1D43-20A3F699F4EB}"/>
              </a:ext>
            </a:extLst>
          </p:cNvPr>
          <p:cNvGrpSpPr/>
          <p:nvPr/>
        </p:nvGrpSpPr>
        <p:grpSpPr>
          <a:xfrm>
            <a:off x="688256" y="6350"/>
            <a:ext cx="5342261" cy="7615319"/>
            <a:chOff x="688256" y="6350"/>
            <a:chExt cx="5342261" cy="7615319"/>
          </a:xfrm>
        </p:grpSpPr>
        <p:pic>
          <p:nvPicPr>
            <p:cNvPr id="3074" name="Picture 2">
              <a:extLst>
                <a:ext uri="{FF2B5EF4-FFF2-40B4-BE49-F238E27FC236}">
                  <a16:creationId xmlns:a16="http://schemas.microsoft.com/office/drawing/2014/main" id="{1746DDAF-4D08-1AAF-EB26-E1264B172DD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1806" y="6350"/>
              <a:ext cx="5178711" cy="3867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75" name="Picture 3">
              <a:extLst>
                <a:ext uri="{FF2B5EF4-FFF2-40B4-BE49-F238E27FC236}">
                  <a16:creationId xmlns:a16="http://schemas.microsoft.com/office/drawing/2014/main" id="{A90679DD-B79F-09BF-702F-1D6F510B7F5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1806" y="3866051"/>
              <a:ext cx="5033284" cy="37556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15FB2006-7CC0-F8CE-D02B-BE40CC48D005}"/>
                </a:ext>
              </a:extLst>
            </p:cNvPr>
            <p:cNvSpPr txBox="1"/>
            <p:nvPr/>
          </p:nvSpPr>
          <p:spPr>
            <a:xfrm>
              <a:off x="692670" y="489456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77055DD5-F2BB-963E-EF45-FDB2F2C808E8}"/>
                </a:ext>
              </a:extLst>
            </p:cNvPr>
            <p:cNvSpPr txBox="1"/>
            <p:nvPr/>
          </p:nvSpPr>
          <p:spPr>
            <a:xfrm>
              <a:off x="688256" y="441541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62733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62A863EF-0DA8-AA52-01FF-EDB864E902F3}"/>
              </a:ext>
            </a:extLst>
          </p:cNvPr>
          <p:cNvSpPr txBox="1"/>
          <p:nvPr/>
        </p:nvSpPr>
        <p:spPr>
          <a:xfrm>
            <a:off x="116114" y="9115663"/>
            <a:ext cx="657497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5.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and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NMR 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acetyl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pyranosyl)-5,7diacetylchrysin.</a:t>
            </a:r>
            <a:endParaRPr lang="es-MX" b="1" dirty="0"/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C24F7D03-90D7-F7E8-1954-9C0E519341A6}"/>
              </a:ext>
            </a:extLst>
          </p:cNvPr>
          <p:cNvGrpSpPr/>
          <p:nvPr/>
        </p:nvGrpSpPr>
        <p:grpSpPr>
          <a:xfrm>
            <a:off x="336177" y="645459"/>
            <a:ext cx="6172200" cy="8194309"/>
            <a:chOff x="0" y="0"/>
            <a:chExt cx="6858001" cy="8799428"/>
          </a:xfrm>
        </p:grpSpPr>
        <p:pic>
          <p:nvPicPr>
            <p:cNvPr id="4098" name="Picture 2">
              <a:extLst>
                <a:ext uri="{FF2B5EF4-FFF2-40B4-BE49-F238E27FC236}">
                  <a16:creationId xmlns:a16="http://schemas.microsoft.com/office/drawing/2014/main" id="{0AF385CD-DB7B-594F-ED0C-6EE4A6531B9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820"/>
            <a:stretch/>
          </p:blipFill>
          <p:spPr bwMode="auto">
            <a:xfrm>
              <a:off x="1" y="432763"/>
              <a:ext cx="6858000" cy="34751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EA551A0D-56D1-F8FD-0199-4139A5A32A7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3002"/>
            <a:stretch/>
          </p:blipFill>
          <p:spPr bwMode="auto">
            <a:xfrm>
              <a:off x="1" y="192823"/>
              <a:ext cx="6858000" cy="8298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2">
              <a:extLst>
                <a:ext uri="{FF2B5EF4-FFF2-40B4-BE49-F238E27FC236}">
                  <a16:creationId xmlns:a16="http://schemas.microsoft.com/office/drawing/2014/main" id="{2BFEDA45-C797-E8B8-E800-AF49E3BCA6E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62" y="3958391"/>
              <a:ext cx="6848538" cy="48410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B126D401-158F-B0E3-F3ED-0C3CA11F6136}"/>
                </a:ext>
              </a:extLst>
            </p:cNvPr>
            <p:cNvSpPr txBox="1"/>
            <p:nvPr/>
          </p:nvSpPr>
          <p:spPr>
            <a:xfrm>
              <a:off x="0" y="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9659C7E9-9F3B-57EB-3ADC-B9BD83FF5C13}"/>
                </a:ext>
              </a:extLst>
            </p:cNvPr>
            <p:cNvSpPr txBox="1"/>
            <p:nvPr/>
          </p:nvSpPr>
          <p:spPr>
            <a:xfrm>
              <a:off x="0" y="379424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372807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72AB1FB2-5F9B-E29B-D0DA-6E71392515BB}"/>
              </a:ext>
            </a:extLst>
          </p:cNvPr>
          <p:cNvSpPr txBox="1"/>
          <p:nvPr/>
        </p:nvSpPr>
        <p:spPr>
          <a:xfrm>
            <a:off x="43542" y="9030065"/>
            <a:ext cx="6858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6. COSY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and NOESY (B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)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acetyl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acetylchrysin.</a:t>
            </a:r>
            <a:endParaRPr lang="es-MX" b="1" dirty="0"/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60F0320B-644B-73A5-64BA-EF3D82A4B768}"/>
              </a:ext>
            </a:extLst>
          </p:cNvPr>
          <p:cNvGrpSpPr/>
          <p:nvPr/>
        </p:nvGrpSpPr>
        <p:grpSpPr>
          <a:xfrm>
            <a:off x="604413" y="489456"/>
            <a:ext cx="5685073" cy="8342034"/>
            <a:chOff x="604413" y="489456"/>
            <a:chExt cx="5685073" cy="8342034"/>
          </a:xfrm>
        </p:grpSpPr>
        <p:pic>
          <p:nvPicPr>
            <p:cNvPr id="6146" name="Picture 2">
              <a:extLst>
                <a:ext uri="{FF2B5EF4-FFF2-40B4-BE49-F238E27FC236}">
                  <a16:creationId xmlns:a16="http://schemas.microsoft.com/office/drawing/2014/main" id="{1E68386D-6A90-7E0F-D7C7-8D59E7EF4BC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4413" y="512762"/>
              <a:ext cx="5613120" cy="41955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47" name="Picture 3">
              <a:extLst>
                <a:ext uri="{FF2B5EF4-FFF2-40B4-BE49-F238E27FC236}">
                  <a16:creationId xmlns:a16="http://schemas.microsoft.com/office/drawing/2014/main" id="{F2E884C9-5C67-7575-D38E-CE806460C71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8782" y="4635956"/>
              <a:ext cx="5630704" cy="41955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59F056EA-E4FE-3D28-2B43-108BC3DC6187}"/>
                </a:ext>
              </a:extLst>
            </p:cNvPr>
            <p:cNvSpPr txBox="1"/>
            <p:nvPr/>
          </p:nvSpPr>
          <p:spPr>
            <a:xfrm>
              <a:off x="692670" y="489456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0CF9DA24-3C68-4F65-ADC5-635996B869A7}"/>
                </a:ext>
              </a:extLst>
            </p:cNvPr>
            <p:cNvSpPr txBox="1"/>
            <p:nvPr/>
          </p:nvSpPr>
          <p:spPr>
            <a:xfrm>
              <a:off x="688256" y="481165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992347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>
            <a:extLst>
              <a:ext uri="{FF2B5EF4-FFF2-40B4-BE49-F238E27FC236}">
                <a16:creationId xmlns:a16="http://schemas.microsoft.com/office/drawing/2014/main" id="{8D4472FF-F72D-4DF8-D34A-7FDC96AF84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7078" y="877206"/>
            <a:ext cx="5636612" cy="42001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C5A74F7F-7652-BFA9-D144-90389738377A}"/>
              </a:ext>
            </a:extLst>
          </p:cNvPr>
          <p:cNvSpPr txBox="1"/>
          <p:nvPr/>
        </p:nvSpPr>
        <p:spPr>
          <a:xfrm>
            <a:off x="58056" y="4995670"/>
            <a:ext cx="6858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7. HETCOR spectrum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acetyl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acetylchrysin.</a:t>
            </a:r>
            <a:endParaRPr lang="es-MX" b="1" dirty="0"/>
          </a:p>
        </p:txBody>
      </p:sp>
    </p:spTree>
    <p:extLst>
      <p:ext uri="{BB962C8B-B14F-4D97-AF65-F5344CB8AC3E}">
        <p14:creationId xmlns:p14="http://schemas.microsoft.com/office/powerpoint/2010/main" val="19275720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CD039699-FD50-9BEB-3D6F-A16E52639371}"/>
              </a:ext>
            </a:extLst>
          </p:cNvPr>
          <p:cNvSpPr txBox="1"/>
          <p:nvPr/>
        </p:nvSpPr>
        <p:spPr>
          <a:xfrm>
            <a:off x="-2" y="8829398"/>
            <a:ext cx="650165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8.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MR spectra of 8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(2'',3'',4'',6''-tetraethylcarbonate-</a:t>
            </a:r>
            <a:r>
              <a:rPr lang="es-MX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pyranosyl)-5,7-diethylcarbonatechrysin.</a:t>
            </a:r>
            <a:endParaRPr lang="es-MX" b="1" dirty="0"/>
          </a:p>
        </p:txBody>
      </p:sp>
      <p:grpSp>
        <p:nvGrpSpPr>
          <p:cNvPr id="9" name="Grupo 8">
            <a:extLst>
              <a:ext uri="{FF2B5EF4-FFF2-40B4-BE49-F238E27FC236}">
                <a16:creationId xmlns:a16="http://schemas.microsoft.com/office/drawing/2014/main" id="{6EC620E8-8372-933C-6E3B-1B36E843B0C0}"/>
              </a:ext>
            </a:extLst>
          </p:cNvPr>
          <p:cNvGrpSpPr/>
          <p:nvPr/>
        </p:nvGrpSpPr>
        <p:grpSpPr>
          <a:xfrm>
            <a:off x="356347" y="345546"/>
            <a:ext cx="6145306" cy="8456957"/>
            <a:chOff x="-1" y="47270"/>
            <a:chExt cx="6858001" cy="9068593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389DAB35-E3A7-BEC2-6A9C-A7FA7AED3046}"/>
                </a:ext>
              </a:extLst>
            </p:cNvPr>
            <p:cNvGrpSpPr/>
            <p:nvPr/>
          </p:nvGrpSpPr>
          <p:grpSpPr>
            <a:xfrm>
              <a:off x="-1" y="4752162"/>
              <a:ext cx="6858001" cy="4363701"/>
              <a:chOff x="-1" y="5004834"/>
              <a:chExt cx="6858001" cy="4363701"/>
            </a:xfrm>
          </p:grpSpPr>
          <p:pic>
            <p:nvPicPr>
              <p:cNvPr id="2" name="Picture 2">
                <a:extLst>
                  <a:ext uri="{FF2B5EF4-FFF2-40B4-BE49-F238E27FC236}">
                    <a16:creationId xmlns:a16="http://schemas.microsoft.com/office/drawing/2014/main" id="{01CE1B13-7ADA-D90D-16AF-0F854E88F1F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901"/>
              <a:stretch/>
            </p:blipFill>
            <p:spPr bwMode="auto">
              <a:xfrm>
                <a:off x="-1" y="5450304"/>
                <a:ext cx="6858001" cy="3918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" name="Picture 2">
                <a:extLst>
                  <a:ext uri="{FF2B5EF4-FFF2-40B4-BE49-F238E27FC236}">
                    <a16:creationId xmlns:a16="http://schemas.microsoft.com/office/drawing/2014/main" id="{9D32BC15-B682-64CF-8AF0-7D84C5BC643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9280"/>
              <a:stretch/>
            </p:blipFill>
            <p:spPr bwMode="auto">
              <a:xfrm>
                <a:off x="-1" y="5004834"/>
                <a:ext cx="6858001" cy="4936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8" name="Grupo 7">
              <a:extLst>
                <a:ext uri="{FF2B5EF4-FFF2-40B4-BE49-F238E27FC236}">
                  <a16:creationId xmlns:a16="http://schemas.microsoft.com/office/drawing/2014/main" id="{5D6CA07E-7BDA-F144-A597-439AF55BC543}"/>
                </a:ext>
              </a:extLst>
            </p:cNvPr>
            <p:cNvGrpSpPr/>
            <p:nvPr/>
          </p:nvGrpSpPr>
          <p:grpSpPr>
            <a:xfrm>
              <a:off x="0" y="47270"/>
              <a:ext cx="6858000" cy="5529183"/>
              <a:chOff x="0" y="47270"/>
              <a:chExt cx="6858000" cy="5529183"/>
            </a:xfrm>
          </p:grpSpPr>
          <p:pic>
            <p:nvPicPr>
              <p:cNvPr id="8194" name="Picture 2">
                <a:extLst>
                  <a:ext uri="{FF2B5EF4-FFF2-40B4-BE49-F238E27FC236}">
                    <a16:creationId xmlns:a16="http://schemas.microsoft.com/office/drawing/2014/main" id="{26AFFD0F-FA70-238D-635E-6E9310BA7F4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47270"/>
                <a:ext cx="6858000" cy="47906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CuadroTexto 5">
                <a:extLst>
                  <a:ext uri="{FF2B5EF4-FFF2-40B4-BE49-F238E27FC236}">
                    <a16:creationId xmlns:a16="http://schemas.microsoft.com/office/drawing/2014/main" id="{673147B7-FBBC-B4A0-3880-94547CC1FD5E}"/>
                  </a:ext>
                </a:extLst>
              </p:cNvPr>
              <p:cNvSpPr txBox="1"/>
              <p:nvPr/>
            </p:nvSpPr>
            <p:spPr>
              <a:xfrm>
                <a:off x="128399" y="528527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23BAE2A7-F227-05AC-04D2-F4305F369642}"/>
                  </a:ext>
                </a:extLst>
              </p:cNvPr>
              <p:cNvSpPr txBox="1"/>
              <p:nvPr/>
            </p:nvSpPr>
            <p:spPr>
              <a:xfrm>
                <a:off x="119012" y="5314843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949251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29</TotalTime>
  <Words>636</Words>
  <Application>Microsoft Office PowerPoint</Application>
  <PresentationFormat>A4 Paper (210x297 mm)</PresentationFormat>
  <Paragraphs>107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zahara Rodriguez Luna</dc:creator>
  <cp:lastModifiedBy>MDPI</cp:lastModifiedBy>
  <cp:revision>275</cp:revision>
  <cp:lastPrinted>2020-12-02T14:34:22Z</cp:lastPrinted>
  <dcterms:created xsi:type="dcterms:W3CDTF">2017-02-10T14:45:00Z</dcterms:created>
  <dcterms:modified xsi:type="dcterms:W3CDTF">2024-10-17T15:06:40Z</dcterms:modified>
</cp:coreProperties>
</file>